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128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RF0308\Desktop\MND\PureClin%20AD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266951006124235"/>
          <c:y val="0.1335129470756454"/>
          <c:w val="0.64404761904761909"/>
          <c:h val="0.80746268656716425"/>
        </c:manualLayout>
      </c:layout>
      <c:pieChart>
        <c:varyColors val="1"/>
        <c:ser>
          <c:idx val="0"/>
          <c:order val="0"/>
          <c:spPr>
            <a:ln w="25400">
              <a:solidFill>
                <a:schemeClr val="tx1"/>
              </a:solidFill>
            </a:ln>
          </c:spPr>
          <c:dPt>
            <c:idx val="1"/>
            <c:bubble3D val="0"/>
            <c:spPr>
              <a:solidFill>
                <a:schemeClr val="tx2">
                  <a:lumMod val="60000"/>
                  <a:lumOff val="4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2"/>
            <c:bubble3D val="0"/>
            <c:spPr>
              <a:solidFill>
                <a:schemeClr val="tx2">
                  <a:lumMod val="20000"/>
                  <a:lumOff val="8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3"/>
            <c:bubble3D val="0"/>
            <c:spPr>
              <a:solidFill>
                <a:schemeClr val="accent3">
                  <a:lumMod val="7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4"/>
            <c:bubble3D val="0"/>
            <c:spPr>
              <a:solidFill>
                <a:schemeClr val="accent3">
                  <a:lumMod val="40000"/>
                  <a:lumOff val="6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5"/>
            <c:bubble3D val="0"/>
            <c:spPr>
              <a:solidFill>
                <a:schemeClr val="accent6">
                  <a:lumMod val="7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6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8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10"/>
            <c:bubble3D val="0"/>
            <c:spPr>
              <a:solidFill>
                <a:schemeClr val="accent4">
                  <a:lumMod val="40000"/>
                  <a:lumOff val="6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11"/>
            <c:bubble3D val="0"/>
            <c:spPr>
              <a:solidFill>
                <a:schemeClr val="accent4">
                  <a:lumMod val="20000"/>
                  <a:lumOff val="8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12"/>
            <c:bubble3D val="0"/>
            <c:spPr>
              <a:solidFill>
                <a:schemeClr val="bg2">
                  <a:lumMod val="75000"/>
                </a:schemeClr>
              </a:solidFill>
              <a:ln w="25400">
                <a:solidFill>
                  <a:schemeClr val="tx1"/>
                </a:solidFill>
              </a:ln>
            </c:spPr>
          </c:dPt>
          <c:dPt>
            <c:idx val="13"/>
            <c:bubble3D val="0"/>
            <c:spPr>
              <a:solidFill>
                <a:schemeClr val="bg2">
                  <a:lumMod val="90000"/>
                </a:schemeClr>
              </a:solidFill>
              <a:ln w="25400">
                <a:solidFill>
                  <a:schemeClr val="tx1"/>
                </a:solidFill>
              </a:ln>
            </c:spPr>
          </c:dPt>
          <c:dLbls>
            <c:dLbl>
              <c:idx val="4"/>
              <c:layout>
                <c:manualLayout>
                  <c:x val="-1.3646947977656639E-2"/>
                  <c:y val="-4.278273162874508E-4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5"/>
              <c:layout>
                <c:manualLayout>
                  <c:x val="-1.0798505955986271E-2"/>
                  <c:y val="-1.9635558800183091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6"/>
              <c:layout>
                <c:manualLayout>
                  <c:x val="-9.6495638467132532E-3"/>
                  <c:y val="-2.5294863276740316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7"/>
              <c:layout>
                <c:manualLayout>
                  <c:x val="-1.0421461030451362E-2"/>
                  <c:y val="7.8334911906209215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8"/>
              <c:layout>
                <c:manualLayout>
                  <c:x val="3.5801115577852346E-3"/>
                  <c:y val="2.9385016280505331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9"/>
              <c:layout>
                <c:manualLayout>
                  <c:x val="-6.1756942829403706E-3"/>
                  <c:y val="7.1551289481992485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10"/>
              <c:layout>
                <c:manualLayout>
                  <c:x val="7.45392058060253E-4"/>
                  <c:y val="1.1358185253773261E-2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11"/>
              <c:layout>
                <c:manualLayout>
                  <c:x val="1.5273154146870882E-2"/>
                  <c:y val="-2.4275152320502127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12"/>
              <c:layout>
                <c:manualLayout>
                  <c:x val="-3.0730441395247533E-3"/>
                  <c:y val="-3.5970728075507617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13"/>
              <c:layout>
                <c:manualLayout>
                  <c:x val="2.4855753790269889E-3"/>
                  <c:y val="-5.9073495525806133E-3"/>
                </c:manualLayout>
              </c:layout>
              <c:showLegendKey val="0"/>
              <c:showVal val="0"/>
              <c:showCatName val="1"/>
              <c:showSerName val="0"/>
              <c:showPercent val="1"/>
              <c:showBubbleSize val="0"/>
            </c:dLbl>
            <c:txPr>
              <a:bodyPr/>
              <a:lstStyle/>
              <a:p>
                <a:pPr>
                  <a:defRPr sz="1200" b="1"/>
                </a:pPr>
                <a:endParaRPr lang="en-US"/>
              </a:p>
            </c:txPr>
            <c:showLegendKey val="0"/>
            <c:showVal val="0"/>
            <c:showCatName val="1"/>
            <c:showSerName val="0"/>
            <c:showPercent val="1"/>
            <c:showBubbleSize val="0"/>
            <c:showLeaderLines val="1"/>
          </c:dLbls>
          <c:cat>
            <c:strRef>
              <c:f>'Pure AD copy'!$AB$7:$AB$20</c:f>
              <c:strCache>
                <c:ptCount val="14"/>
                <c:pt idx="0">
                  <c:v>PureAD</c:v>
                </c:pt>
                <c:pt idx="1">
                  <c:v>AD/LBD</c:v>
                </c:pt>
                <c:pt idx="2">
                  <c:v>AD/LBD+</c:v>
                </c:pt>
                <c:pt idx="3">
                  <c:v>AD/Vas</c:v>
                </c:pt>
                <c:pt idx="4">
                  <c:v>AD/Vas+</c:v>
                </c:pt>
                <c:pt idx="5">
                  <c:v>AD/CAA</c:v>
                </c:pt>
                <c:pt idx="6">
                  <c:v>AD/CAA+</c:v>
                </c:pt>
                <c:pt idx="7">
                  <c:v>AD/HpScl</c:v>
                </c:pt>
                <c:pt idx="8">
                  <c:v>AD/HpScl+</c:v>
                </c:pt>
                <c:pt idx="9">
                  <c:v>AD/Other</c:v>
                </c:pt>
                <c:pt idx="10">
                  <c:v>AD/Other+</c:v>
                </c:pt>
                <c:pt idx="11">
                  <c:v>Secondary AD</c:v>
                </c:pt>
                <c:pt idx="12">
                  <c:v>No AD</c:v>
                </c:pt>
                <c:pt idx="13">
                  <c:v>Normal</c:v>
                </c:pt>
              </c:strCache>
            </c:strRef>
          </c:cat>
          <c:val>
            <c:numRef>
              <c:f>'Pure AD copy'!$AC$7:$AC$20</c:f>
              <c:numCache>
                <c:formatCode>0.00</c:formatCode>
                <c:ptCount val="14"/>
                <c:pt idx="0">
                  <c:v>108</c:v>
                </c:pt>
                <c:pt idx="1">
                  <c:v>73</c:v>
                </c:pt>
                <c:pt idx="2">
                  <c:v>104</c:v>
                </c:pt>
                <c:pt idx="3">
                  <c:v>41</c:v>
                </c:pt>
                <c:pt idx="4">
                  <c:v>46</c:v>
                </c:pt>
                <c:pt idx="5">
                  <c:v>17</c:v>
                </c:pt>
                <c:pt idx="6">
                  <c:v>53</c:v>
                </c:pt>
                <c:pt idx="7">
                  <c:v>20</c:v>
                </c:pt>
                <c:pt idx="8">
                  <c:v>24</c:v>
                </c:pt>
                <c:pt idx="9">
                  <c:v>21</c:v>
                </c:pt>
                <c:pt idx="10" formatCode="General">
                  <c:v>25</c:v>
                </c:pt>
                <c:pt idx="11">
                  <c:v>15</c:v>
                </c:pt>
                <c:pt idx="12">
                  <c:v>74</c:v>
                </c:pt>
                <c:pt idx="13">
                  <c:v>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659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065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962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507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210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361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97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5154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171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548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542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11476-3E4F-4CE6-92CE-729FF8E51630}" type="datetimeFigureOut">
              <a:rPr lang="en-US" smtClean="0"/>
              <a:t>10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6BB91A-E644-4A62-91EF-A03A818F1E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3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3772931471"/>
              </p:ext>
            </p:extLst>
          </p:nvPr>
        </p:nvGraphicFramePr>
        <p:xfrm>
          <a:off x="1371600" y="685800"/>
          <a:ext cx="6400800" cy="5105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85800" y="5791200"/>
            <a:ext cx="25637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Supplemental Figure </a:t>
            </a:r>
            <a:r>
              <a:rPr lang="en-US" sz="2000" b="1" dirty="0" smtClean="0"/>
              <a:t>3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343972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9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 Deture</dc:creator>
  <cp:lastModifiedBy>Michael  Deture</cp:lastModifiedBy>
  <cp:revision>1</cp:revision>
  <dcterms:created xsi:type="dcterms:W3CDTF">2018-10-07T16:29:50Z</dcterms:created>
  <dcterms:modified xsi:type="dcterms:W3CDTF">2018-10-07T16:37:40Z</dcterms:modified>
</cp:coreProperties>
</file>